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8" r:id="rId2"/>
  </p:sldIdLst>
  <p:sldSz cx="6858000" cy="9906000" type="A4"/>
  <p:notesSz cx="6797675" cy="9926638"/>
  <p:defaultTextStyle>
    <a:defPPr>
      <a:defRPr lang="en-US"/>
    </a:defPPr>
    <a:lvl1pPr marL="0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FF7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0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Papers\Fusarium%20in%20planta%20transcriptome\Fom%20transcriptome%20paper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Papers\Fusarium%20in%20planta%20transcriptome\Fom%20transcriptome%20paper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NAseq disease conf'!$A$4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Disease assay data'!$C$21:$F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798692684790379</c:v>
                  </c:pt>
                  <c:pt idx="2">
                    <c:v>3.3592740617910621</c:v>
                  </c:pt>
                  <c:pt idx="3">
                    <c:v>6.3932007533797979</c:v>
                  </c:pt>
                </c:numCache>
              </c:numRef>
            </c:plus>
            <c:minus>
              <c:numRef>
                <c:f>'Disease assay data'!$C$21:$F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798692684790379</c:v>
                  </c:pt>
                  <c:pt idx="2">
                    <c:v>3.3592740617910621</c:v>
                  </c:pt>
                  <c:pt idx="3">
                    <c:v>6.39320075337979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NAseq disease conf'!$B$3:$C$3</c:f>
              <c:strCache>
                <c:ptCount val="2"/>
                <c:pt idx="0">
                  <c:v>A17</c:v>
                </c:pt>
                <c:pt idx="1">
                  <c:v>DZA315</c:v>
                </c:pt>
              </c:strCache>
            </c:strRef>
          </c:cat>
          <c:val>
            <c:numRef>
              <c:f>'RNAseq disease conf'!$B$4:$C$4</c:f>
              <c:numCache>
                <c:formatCode>0.00</c:formatCode>
                <c:ptCount val="2"/>
                <c:pt idx="0">
                  <c:v>100</c:v>
                </c:pt>
                <c:pt idx="1">
                  <c:v>23.3333333333333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116144"/>
        <c:axId val="193648128"/>
      </c:barChart>
      <c:catAx>
        <c:axId val="194116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648128"/>
        <c:crosses val="autoZero"/>
        <c:auto val="1"/>
        <c:lblAlgn val="ctr"/>
        <c:lblOffset val="100"/>
        <c:noMultiLvlLbl val="0"/>
      </c:catAx>
      <c:valAx>
        <c:axId val="193648128"/>
        <c:scaling>
          <c:orientation val="minMax"/>
          <c:max val="10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116144"/>
        <c:crosses val="autoZero"/>
        <c:crossBetween val="between"/>
        <c:majorUnit val="20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62062400314651"/>
          <c:y val="5.8922061825605131E-2"/>
          <c:w val="0.84292535672698921"/>
          <c:h val="0.831046587926509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NAseq disease conf'!$F$4</c:f>
              <c:strCache>
                <c:ptCount val="1"/>
                <c:pt idx="0">
                  <c:v>A17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NAseq disease conf'!$H$5:$H$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2117568273525308</c:v>
                  </c:pt>
                  <c:pt idx="2">
                    <c:v>8.5096294339676319</c:v>
                  </c:pt>
                  <c:pt idx="3">
                    <c:v>9.0971765229468406</c:v>
                  </c:pt>
                </c:numCache>
              </c:numRef>
            </c:plus>
            <c:minus>
              <c:numRef>
                <c:f>'RNAseq disease conf'!$H$5:$H$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2117568273525308</c:v>
                  </c:pt>
                  <c:pt idx="2">
                    <c:v>8.5096294339676319</c:v>
                  </c:pt>
                  <c:pt idx="3">
                    <c:v>9.09717652294684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NAseq disease conf'!$E$5:$E$8</c:f>
              <c:numCache>
                <c:formatCode>General</c:formatCode>
                <c:ptCount val="4"/>
                <c:pt idx="0">
                  <c:v>7</c:v>
                </c:pt>
                <c:pt idx="1">
                  <c:v>10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'RNAseq disease conf'!$F$5:$F$8</c:f>
              <c:numCache>
                <c:formatCode>General</c:formatCode>
                <c:ptCount val="4"/>
                <c:pt idx="0">
                  <c:v>0</c:v>
                </c:pt>
                <c:pt idx="1">
                  <c:v>26.666666666666668</c:v>
                </c:pt>
                <c:pt idx="2">
                  <c:v>30</c:v>
                </c:pt>
                <c:pt idx="3">
                  <c:v>40</c:v>
                </c:pt>
              </c:numCache>
            </c:numRef>
          </c:val>
        </c:ser>
        <c:ser>
          <c:idx val="1"/>
          <c:order val="1"/>
          <c:tx>
            <c:strRef>
              <c:f>'RNAseq disease conf'!$G$4</c:f>
              <c:strCache>
                <c:ptCount val="1"/>
                <c:pt idx="0">
                  <c:v>DZA315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NAseq disease conf'!$I$5:$I$8</c:f>
                <c:numCache>
                  <c:formatCode>General</c:formatCode>
                  <c:ptCount val="4"/>
                  <c:pt idx="0">
                    <c:v>7.4278135270820753</c:v>
                  </c:pt>
                  <c:pt idx="1">
                    <c:v>9.201865544655373</c:v>
                  </c:pt>
                  <c:pt idx="2">
                    <c:v>3.3333333333333304</c:v>
                  </c:pt>
                  <c:pt idx="3">
                    <c:v>0</c:v>
                  </c:pt>
                </c:numCache>
              </c:numRef>
            </c:plus>
            <c:minus>
              <c:numRef>
                <c:f>'RNAseq disease conf'!$I$5:$I$8</c:f>
                <c:numCache>
                  <c:formatCode>General</c:formatCode>
                  <c:ptCount val="4"/>
                  <c:pt idx="0">
                    <c:v>7.4278135270820753</c:v>
                  </c:pt>
                  <c:pt idx="1">
                    <c:v>9.201865544655373</c:v>
                  </c:pt>
                  <c:pt idx="2">
                    <c:v>3.3333333333333304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NAseq disease conf'!$E$5:$E$8</c:f>
              <c:numCache>
                <c:formatCode>General</c:formatCode>
                <c:ptCount val="4"/>
                <c:pt idx="0">
                  <c:v>7</c:v>
                </c:pt>
                <c:pt idx="1">
                  <c:v>10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'RNAseq disease conf'!$G$5:$G$8</c:f>
              <c:numCache>
                <c:formatCode>General</c:formatCode>
                <c:ptCount val="4"/>
                <c:pt idx="0">
                  <c:v>20</c:v>
                </c:pt>
                <c:pt idx="1">
                  <c:v>56.666666666666664</c:v>
                </c:pt>
                <c:pt idx="2">
                  <c:v>96.666666666666671</c:v>
                </c:pt>
                <c:pt idx="3">
                  <c:v>1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187376"/>
        <c:axId val="193663392"/>
      </c:barChart>
      <c:catAx>
        <c:axId val="194187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663392"/>
        <c:crosses val="autoZero"/>
        <c:auto val="1"/>
        <c:lblAlgn val="ctr"/>
        <c:lblOffset val="100"/>
        <c:noMultiLvlLbl val="0"/>
      </c:catAx>
      <c:valAx>
        <c:axId val="193663392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187376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3759912701844415"/>
          <c:y val="6.076334208223972E-2"/>
          <c:w val="0.23969925634295713"/>
          <c:h val="0.133681102362204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7227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4813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428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5524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0004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636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358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296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0319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3487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928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BA8CA-4CF0-4E11-93E7-4864458BAA90}" type="datetimeFigureOut">
              <a:rPr lang="en-AU" smtClean="0"/>
              <a:t>10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8262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8423" y="3653210"/>
            <a:ext cx="52646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b="1" dirty="0" smtClean="0">
                <a:cs typeface="Arial" panose="020B0604020202020204" pitchFamily="34" charset="0"/>
              </a:rPr>
              <a:t>Additional file 1. </a:t>
            </a:r>
            <a:r>
              <a:rPr lang="en-AU" sz="1200" b="1" dirty="0" smtClean="0">
                <a:cs typeface="Arial" panose="020B0604020202020204" pitchFamily="34" charset="0"/>
              </a:rPr>
              <a:t>Confirmation </a:t>
            </a:r>
            <a:r>
              <a:rPr lang="en-AU" sz="1200" b="1" dirty="0">
                <a:cs typeface="Arial" panose="020B0604020202020204" pitchFamily="34" charset="0"/>
              </a:rPr>
              <a:t>of disease progression in experiment from which plants were sampled for </a:t>
            </a:r>
            <a:r>
              <a:rPr lang="en-AU" sz="1200" b="1" dirty="0" smtClean="0">
                <a:cs typeface="Arial" panose="020B0604020202020204" pitchFamily="34" charset="0"/>
              </a:rPr>
              <a:t>RNA-Seq</a:t>
            </a:r>
            <a:r>
              <a:rPr lang="en-AU" sz="1200" b="1" dirty="0">
                <a:cs typeface="Arial" panose="020B0604020202020204" pitchFamily="34" charset="0"/>
              </a:rPr>
              <a:t>. </a:t>
            </a:r>
            <a:r>
              <a:rPr lang="en-AU" sz="1200" dirty="0" smtClean="0">
                <a:cs typeface="Arial" panose="020B0604020202020204" pitchFamily="34" charset="0"/>
              </a:rPr>
              <a:t>A-B) Percentage of A17 and DZA315 plants diseased and their survival at 21 days post inoculation (dpi) with </a:t>
            </a:r>
            <a:r>
              <a:rPr lang="en-AU" sz="1200" i="1" dirty="0" err="1" smtClean="0">
                <a:cs typeface="Arial" panose="020B0604020202020204" pitchFamily="34" charset="0"/>
              </a:rPr>
              <a:t>Fom</a:t>
            </a:r>
            <a:r>
              <a:rPr lang="en-AU" sz="1200" dirty="0" smtClean="0">
                <a:cs typeface="Arial" panose="020B0604020202020204" pitchFamily="34" charset="0"/>
              </a:rPr>
              <a:t>. </a:t>
            </a:r>
            <a:r>
              <a:rPr lang="en-AU" sz="1200" dirty="0">
                <a:cs typeface="Arial" panose="020B0604020202020204" pitchFamily="34" charset="0"/>
              </a:rPr>
              <a:t>V</a:t>
            </a:r>
            <a:r>
              <a:rPr lang="en-AU" sz="1200" dirty="0" smtClean="0">
                <a:cs typeface="Arial" panose="020B0604020202020204" pitchFamily="34" charset="0"/>
              </a:rPr>
              <a:t>alues are averages </a:t>
            </a:r>
            <a:r>
              <a:rPr lang="en-AU" sz="1200" dirty="0" smtClean="0">
                <a:cs typeface="Arial" panose="020B0604020202020204" pitchFamily="34" charset="0"/>
                <a:sym typeface="Symbol" panose="05050102010706020507" pitchFamily="18" charset="2"/>
              </a:rPr>
              <a:t> SE (n=10). </a:t>
            </a:r>
            <a:endParaRPr lang="en-AU" sz="1200" dirty="0" smtClean="0">
              <a:cs typeface="Arial" panose="020B0604020202020204" pitchFamily="34" charset="0"/>
              <a:sym typeface="Symbol" panose="05050102010706020507" pitchFamily="18" charset="2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96984" y="463063"/>
            <a:ext cx="297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/>
              <a:t>A</a:t>
            </a:r>
            <a:endParaRPr lang="en-AU" sz="12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5058409" y="3323685"/>
            <a:ext cx="574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Line</a:t>
            </a:r>
            <a:endParaRPr lang="en-AU" sz="12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55993" y="1603641"/>
            <a:ext cx="1393962" cy="2837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dirty="0" smtClean="0"/>
              <a:t>Diseased plants (%)</a:t>
            </a:r>
            <a:endParaRPr lang="en-AU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4161271" y="454815"/>
            <a:ext cx="297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/>
              <a:t>B</a:t>
            </a:r>
            <a:endParaRPr lang="en-AU" sz="1200" b="1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3790562" y="1719858"/>
            <a:ext cx="10496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Survival (%)</a:t>
            </a:r>
            <a:endParaRPr lang="en-AU" sz="1200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6608233"/>
              </p:ext>
            </p:extLst>
          </p:nvPr>
        </p:nvGraphicFramePr>
        <p:xfrm>
          <a:off x="4351349" y="601562"/>
          <a:ext cx="168369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4553849"/>
              </p:ext>
            </p:extLst>
          </p:nvPr>
        </p:nvGraphicFramePr>
        <p:xfrm>
          <a:off x="885534" y="573743"/>
          <a:ext cx="322389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363978" y="3316943"/>
            <a:ext cx="574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dpi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713029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70</TotalTime>
  <Words>58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tcher, Louise (Agriculture, Floreat)</dc:creator>
  <cp:lastModifiedBy>Thatcher, Louise (Agriculture, Floreat)</cp:lastModifiedBy>
  <cp:revision>136</cp:revision>
  <cp:lastPrinted>2016-06-03T09:23:52Z</cp:lastPrinted>
  <dcterms:created xsi:type="dcterms:W3CDTF">2016-01-07T06:49:03Z</dcterms:created>
  <dcterms:modified xsi:type="dcterms:W3CDTF">2016-06-10T08:06:24Z</dcterms:modified>
</cp:coreProperties>
</file>